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6" r:id="rId2"/>
  </p:sldIdLst>
  <p:sldSz cx="9144000" cy="6858000" type="screen4x3"/>
  <p:notesSz cx="6797675" cy="9926638"/>
  <p:defaultTextStyle>
    <a:defPPr>
      <a:defRPr lang="ko-KR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5pPr>
    <a:lvl6pPr marL="2286000" algn="l" defTabSz="914400" rtl="0" eaLnBrk="1" latinLnBrk="1" hangingPunct="1"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6pPr>
    <a:lvl7pPr marL="2743200" algn="l" defTabSz="914400" rtl="0" eaLnBrk="1" latinLnBrk="1" hangingPunct="1"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7pPr>
    <a:lvl8pPr marL="3200400" algn="l" defTabSz="914400" rtl="0" eaLnBrk="1" latinLnBrk="1" hangingPunct="1"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8pPr>
    <a:lvl9pPr marL="3657600" algn="l" defTabSz="914400" rtl="0" eaLnBrk="1" latinLnBrk="1" hangingPunct="1">
      <a:defRPr kern="1200">
        <a:solidFill>
          <a:schemeClr val="tx1"/>
        </a:solidFill>
        <a:latin typeface="Calibri" panose="020F0502020204030204" pitchFamily="34" charset="0"/>
        <a:ea typeface="맑은 고딕" panose="020B0503020000020004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00FF"/>
    <a:srgbClr val="FF0000"/>
    <a:srgbClr val="FFCCFF"/>
    <a:srgbClr val="003399"/>
    <a:srgbClr val="00CCFF"/>
    <a:srgbClr val="FF0066"/>
    <a:srgbClr val="99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215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452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9C3DD5-880A-4852-BBD2-317535E474D3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59F13D-C2D8-4C68-B811-3AEBB9385A8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5076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6721AF-272D-4211-AD4F-F42AAA36F2DB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3BC6B8-4629-4D27-9596-96FFB0366B9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9955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11267A-3EC6-4683-BAAF-089563FA24F8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80B5A9-EFAE-482D-8665-05BB78BB3F1E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2030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4B4E03-A704-4213-807D-C4EEB65EE3D9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849DF0-6F81-45CC-8856-5832FF172F38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9218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6647D1-2AF8-403B-9171-374089D37C28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D984A7-9B59-4F6C-B5A6-1E92AC97FBDE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8232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39686A-6BB1-4593-95A4-AE3040652AF0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8EBEC5-EDB2-439D-9F35-2FFB22CC887D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2155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F51518-5006-4EFC-AA3C-EBDC6DE8805A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7DDC68-9A41-4E8A-B608-2681925E705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5238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8BB1B0-4513-4EAF-8C9D-EA462F4EF9F8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5108DB-7666-4F5E-8026-4C59D30A3FD3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5565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1DDD11-22FD-4EBD-B78B-C500B438D946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1D5E0C-4796-4E26-93CC-604BCD93E912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6133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BB1A5F-C4B6-4D33-8A22-E7DAE8A4186B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FC2C2E-20FD-4F88-8A99-1FFCC205DE4D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8068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ko-KR" altLang="en-US" noProof="0" smtClean="0"/>
              <a:t>그림을 추가하려면 아이콘을 클릭하십시오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60DD3F-2D4C-4559-BB0F-6027153AE123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A8F507-B4FE-4B12-B83E-2CF6E2E9FE7E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9781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  <a:endParaRPr lang="en-US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latinLnBrk="1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249CF482-E62D-4D31-92F0-588FB1147347}" type="datetimeFigureOut">
              <a:rPr lang="ko-KR" altLang="en-US"/>
              <a:pPr>
                <a:defRPr/>
              </a:pPr>
              <a:t>2014-07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latinLnBrk="1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latinLnBrk="1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6C187728-7725-4346-8170-6CDBB8E1D3B4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2pPr>
      <a:lvl3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3pPr>
      <a:lvl4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4pPr>
      <a:lvl5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5pPr>
      <a:lvl6pPr marL="4572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6pPr>
      <a:lvl7pPr marL="9144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7pPr>
      <a:lvl8pPr marL="13716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8pPr>
      <a:lvl9pPr marL="18288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맑은 고딕" panose="020B0503020000020004" pitchFamily="50" charset="-127"/>
        </a:defRPr>
      </a:lvl9pPr>
    </p:titleStyle>
    <p:bodyStyle>
      <a:lvl1pPr marL="228600" indent="-228600" algn="l" rtl="0" eaLnBrk="0" fontAlgn="base" latinLnBrk="1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1"/>
          <p:cNvSpPr>
            <a:spLocks noChangeArrowheads="1"/>
          </p:cNvSpPr>
          <p:nvPr/>
        </p:nvSpPr>
        <p:spPr bwMode="auto">
          <a:xfrm>
            <a:off x="0" y="6198778"/>
            <a:ext cx="91440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200" b="1" dirty="0" smtClean="0"/>
              <a:t>FIG </a:t>
            </a:r>
            <a:r>
              <a:rPr lang="en-US" altLang="ko-KR" sz="1200" b="1" dirty="0" smtClean="0"/>
              <a:t>S4 </a:t>
            </a:r>
            <a:r>
              <a:rPr lang="en-US" altLang="ko-KR" sz="1200" dirty="0"/>
              <a:t>Diagram showing the relationships among the 2 type strains and the 2 representative contigs obtained from patient samples. The ANI value indicating genome relatedness was calculated using the complete genome sequence of </a:t>
            </a:r>
            <a:r>
              <a:rPr lang="en-US" altLang="ko-KR" sz="1200" i="1" dirty="0"/>
              <a:t>M. </a:t>
            </a:r>
            <a:r>
              <a:rPr lang="en-US" altLang="ko-KR" sz="1200" i="1" dirty="0" err="1"/>
              <a:t>catarrhalis</a:t>
            </a:r>
            <a:r>
              <a:rPr lang="en-US" altLang="ko-KR" sz="1200" dirty="0"/>
              <a:t> RH4 strain (PRJNA 48809), which shows 100% 16S rRNA gene sequence identity with the type strain of the species.</a:t>
            </a:r>
            <a:endParaRPr kumimoji="1" lang="en-US" altLang="ko-KR" sz="1800" dirty="0">
              <a:latin typeface="굴림" panose="020B0600000101010101" pitchFamily="50" charset="-127"/>
              <a:ea typeface="굴림" panose="020B0600000101010101" pitchFamily="50" charset="-127"/>
            </a:endParaRPr>
          </a:p>
        </p:txBody>
      </p:sp>
      <p:sp>
        <p:nvSpPr>
          <p:cNvPr id="10" name="자유형 9"/>
          <p:cNvSpPr/>
          <p:nvPr/>
        </p:nvSpPr>
        <p:spPr>
          <a:xfrm>
            <a:off x="2520950" y="134528"/>
            <a:ext cx="2593975" cy="1201738"/>
          </a:xfrm>
          <a:custGeom>
            <a:avLst/>
            <a:gdLst>
              <a:gd name="connsiteX0" fmla="*/ 0 w 2104429"/>
              <a:gd name="connsiteY0" fmla="*/ 105221 h 1052214"/>
              <a:gd name="connsiteX1" fmla="*/ 105221 w 2104429"/>
              <a:gd name="connsiteY1" fmla="*/ 0 h 1052214"/>
              <a:gd name="connsiteX2" fmla="*/ 1999208 w 2104429"/>
              <a:gd name="connsiteY2" fmla="*/ 0 h 1052214"/>
              <a:gd name="connsiteX3" fmla="*/ 2104429 w 2104429"/>
              <a:gd name="connsiteY3" fmla="*/ 105221 h 1052214"/>
              <a:gd name="connsiteX4" fmla="*/ 2104429 w 2104429"/>
              <a:gd name="connsiteY4" fmla="*/ 946993 h 1052214"/>
              <a:gd name="connsiteX5" fmla="*/ 1999208 w 2104429"/>
              <a:gd name="connsiteY5" fmla="*/ 1052214 h 1052214"/>
              <a:gd name="connsiteX6" fmla="*/ 105221 w 2104429"/>
              <a:gd name="connsiteY6" fmla="*/ 1052214 h 1052214"/>
              <a:gd name="connsiteX7" fmla="*/ 0 w 2104429"/>
              <a:gd name="connsiteY7" fmla="*/ 946993 h 1052214"/>
              <a:gd name="connsiteX8" fmla="*/ 0 w 2104429"/>
              <a:gd name="connsiteY8" fmla="*/ 105221 h 10522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104429" h="1052214">
                <a:moveTo>
                  <a:pt x="0" y="105221"/>
                </a:moveTo>
                <a:cubicBezTo>
                  <a:pt x="0" y="47109"/>
                  <a:pt x="47109" y="0"/>
                  <a:pt x="105221" y="0"/>
                </a:cubicBezTo>
                <a:lnTo>
                  <a:pt x="1999208" y="0"/>
                </a:lnTo>
                <a:cubicBezTo>
                  <a:pt x="2057320" y="0"/>
                  <a:pt x="2104429" y="47109"/>
                  <a:pt x="2104429" y="105221"/>
                </a:cubicBezTo>
                <a:lnTo>
                  <a:pt x="2104429" y="946993"/>
                </a:lnTo>
                <a:cubicBezTo>
                  <a:pt x="2104429" y="1005105"/>
                  <a:pt x="2057320" y="1052214"/>
                  <a:pt x="1999208" y="1052214"/>
                </a:cubicBezTo>
                <a:lnTo>
                  <a:pt x="105221" y="1052214"/>
                </a:lnTo>
                <a:cubicBezTo>
                  <a:pt x="47109" y="1052214"/>
                  <a:pt x="0" y="1005105"/>
                  <a:pt x="0" y="946993"/>
                </a:cubicBezTo>
                <a:lnTo>
                  <a:pt x="0" y="105221"/>
                </a:lnTo>
                <a:close/>
              </a:path>
            </a:pathLst>
          </a:cu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lIns="164168" tIns="164168" rIns="164168" bIns="164168" spcCol="1270" anchor="ctr"/>
          <a:lstStyle/>
          <a:p>
            <a:pPr algn="ctr" defTabSz="1555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r>
              <a:rPr lang="en-US" altLang="ko-KR" sz="2000" dirty="0" err="1">
                <a:solidFill>
                  <a:srgbClr val="FF0000"/>
                </a:solidFill>
              </a:rPr>
              <a:t>Clade</a:t>
            </a:r>
            <a:r>
              <a:rPr lang="en-US" altLang="ko-KR" sz="2000" dirty="0">
                <a:solidFill>
                  <a:srgbClr val="FF0000"/>
                </a:solidFill>
              </a:rPr>
              <a:t> I</a:t>
            </a:r>
            <a:endParaRPr lang="en-US" altLang="ko-KR" sz="2000" i="1" dirty="0">
              <a:solidFill>
                <a:srgbClr val="FF0000"/>
              </a:solidFill>
            </a:endParaRPr>
          </a:p>
          <a:p>
            <a:pPr algn="ctr" defTabSz="1555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r>
              <a:rPr lang="en-US" altLang="ko-KR" sz="2000" b="1" dirty="0" err="1"/>
              <a:t>Contigs</a:t>
            </a:r>
            <a:r>
              <a:rPr lang="en-US" altLang="ko-KR" sz="2000" b="1" dirty="0"/>
              <a:t> from patients</a:t>
            </a:r>
          </a:p>
        </p:txBody>
      </p:sp>
      <p:sp>
        <p:nvSpPr>
          <p:cNvPr id="11" name="자유형 10"/>
          <p:cNvSpPr/>
          <p:nvPr/>
        </p:nvSpPr>
        <p:spPr>
          <a:xfrm rot="2700000">
            <a:off x="4985544" y="1300547"/>
            <a:ext cx="2197100" cy="430212"/>
          </a:xfrm>
          <a:custGeom>
            <a:avLst/>
            <a:gdLst>
              <a:gd name="connsiteX0" fmla="*/ 0 w 1096445"/>
              <a:gd name="connsiteY0" fmla="*/ 184138 h 368275"/>
              <a:gd name="connsiteX1" fmla="*/ 184138 w 1096445"/>
              <a:gd name="connsiteY1" fmla="*/ 0 h 368275"/>
              <a:gd name="connsiteX2" fmla="*/ 184138 w 1096445"/>
              <a:gd name="connsiteY2" fmla="*/ 73655 h 368275"/>
              <a:gd name="connsiteX3" fmla="*/ 912308 w 1096445"/>
              <a:gd name="connsiteY3" fmla="*/ 73655 h 368275"/>
              <a:gd name="connsiteX4" fmla="*/ 912308 w 1096445"/>
              <a:gd name="connsiteY4" fmla="*/ 0 h 368275"/>
              <a:gd name="connsiteX5" fmla="*/ 1096445 w 1096445"/>
              <a:gd name="connsiteY5" fmla="*/ 184138 h 368275"/>
              <a:gd name="connsiteX6" fmla="*/ 912308 w 1096445"/>
              <a:gd name="connsiteY6" fmla="*/ 368275 h 368275"/>
              <a:gd name="connsiteX7" fmla="*/ 912308 w 1096445"/>
              <a:gd name="connsiteY7" fmla="*/ 294620 h 368275"/>
              <a:gd name="connsiteX8" fmla="*/ 184138 w 1096445"/>
              <a:gd name="connsiteY8" fmla="*/ 294620 h 368275"/>
              <a:gd name="connsiteX9" fmla="*/ 184138 w 1096445"/>
              <a:gd name="connsiteY9" fmla="*/ 368275 h 368275"/>
              <a:gd name="connsiteX10" fmla="*/ 0 w 1096445"/>
              <a:gd name="connsiteY10" fmla="*/ 184138 h 368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096445" h="368275">
                <a:moveTo>
                  <a:pt x="0" y="184138"/>
                </a:moveTo>
                <a:lnTo>
                  <a:pt x="184138" y="0"/>
                </a:lnTo>
                <a:lnTo>
                  <a:pt x="184138" y="73655"/>
                </a:lnTo>
                <a:lnTo>
                  <a:pt x="912308" y="73655"/>
                </a:lnTo>
                <a:lnTo>
                  <a:pt x="912308" y="0"/>
                </a:lnTo>
                <a:lnTo>
                  <a:pt x="1096445" y="184138"/>
                </a:lnTo>
                <a:lnTo>
                  <a:pt x="912308" y="368275"/>
                </a:lnTo>
                <a:lnTo>
                  <a:pt x="912308" y="294620"/>
                </a:lnTo>
                <a:lnTo>
                  <a:pt x="184138" y="294620"/>
                </a:lnTo>
                <a:lnTo>
                  <a:pt x="184138" y="368275"/>
                </a:lnTo>
                <a:lnTo>
                  <a:pt x="0" y="184138"/>
                </a:lnTo>
                <a:close/>
              </a:path>
            </a:pathLst>
          </a:custGeom>
          <a:solidFill>
            <a:schemeClr val="accent5">
              <a:lumMod val="20000"/>
              <a:lumOff val="80000"/>
            </a:schemeClr>
          </a:solidFill>
        </p:spPr>
        <p:style>
          <a:lnRef idx="0">
            <a:schemeClr val="accent1">
              <a:tint val="6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tint val="6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tint val="60000"/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lIns="110482" tIns="73653" rIns="110482" bIns="73656" spcCol="1270" anchor="ctr"/>
          <a:lstStyle/>
          <a:p>
            <a:pPr algn="ctr" defTabSz="666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endParaRPr lang="ko-KR" altLang="en-US" sz="1500"/>
          </a:p>
        </p:txBody>
      </p:sp>
      <p:sp>
        <p:nvSpPr>
          <p:cNvPr id="12" name="자유형 11"/>
          <p:cNvSpPr/>
          <p:nvPr/>
        </p:nvSpPr>
        <p:spPr>
          <a:xfrm>
            <a:off x="6477000" y="2428466"/>
            <a:ext cx="2454275" cy="1201737"/>
          </a:xfrm>
          <a:custGeom>
            <a:avLst/>
            <a:gdLst>
              <a:gd name="connsiteX0" fmla="*/ 0 w 2104429"/>
              <a:gd name="connsiteY0" fmla="*/ 105221 h 1052214"/>
              <a:gd name="connsiteX1" fmla="*/ 105221 w 2104429"/>
              <a:gd name="connsiteY1" fmla="*/ 0 h 1052214"/>
              <a:gd name="connsiteX2" fmla="*/ 1999208 w 2104429"/>
              <a:gd name="connsiteY2" fmla="*/ 0 h 1052214"/>
              <a:gd name="connsiteX3" fmla="*/ 2104429 w 2104429"/>
              <a:gd name="connsiteY3" fmla="*/ 105221 h 1052214"/>
              <a:gd name="connsiteX4" fmla="*/ 2104429 w 2104429"/>
              <a:gd name="connsiteY4" fmla="*/ 946993 h 1052214"/>
              <a:gd name="connsiteX5" fmla="*/ 1999208 w 2104429"/>
              <a:gd name="connsiteY5" fmla="*/ 1052214 h 1052214"/>
              <a:gd name="connsiteX6" fmla="*/ 105221 w 2104429"/>
              <a:gd name="connsiteY6" fmla="*/ 1052214 h 1052214"/>
              <a:gd name="connsiteX7" fmla="*/ 0 w 2104429"/>
              <a:gd name="connsiteY7" fmla="*/ 946993 h 1052214"/>
              <a:gd name="connsiteX8" fmla="*/ 0 w 2104429"/>
              <a:gd name="connsiteY8" fmla="*/ 105221 h 10522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104429" h="1052214">
                <a:moveTo>
                  <a:pt x="0" y="105221"/>
                </a:moveTo>
                <a:cubicBezTo>
                  <a:pt x="0" y="47109"/>
                  <a:pt x="47109" y="0"/>
                  <a:pt x="105221" y="0"/>
                </a:cubicBezTo>
                <a:lnTo>
                  <a:pt x="1999208" y="0"/>
                </a:lnTo>
                <a:cubicBezTo>
                  <a:pt x="2057320" y="0"/>
                  <a:pt x="2104429" y="47109"/>
                  <a:pt x="2104429" y="105221"/>
                </a:cubicBezTo>
                <a:lnTo>
                  <a:pt x="2104429" y="946993"/>
                </a:lnTo>
                <a:cubicBezTo>
                  <a:pt x="2104429" y="1005105"/>
                  <a:pt x="2057320" y="1052214"/>
                  <a:pt x="1999208" y="1052214"/>
                </a:cubicBezTo>
                <a:lnTo>
                  <a:pt x="105221" y="1052214"/>
                </a:lnTo>
                <a:cubicBezTo>
                  <a:pt x="47109" y="1052214"/>
                  <a:pt x="0" y="1005105"/>
                  <a:pt x="0" y="946993"/>
                </a:cubicBezTo>
                <a:lnTo>
                  <a:pt x="0" y="105221"/>
                </a:lnTo>
                <a:close/>
              </a:path>
            </a:pathLst>
          </a:cu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lIns="164168" tIns="164168" rIns="164168" bIns="164168" spcCol="1270" anchor="ctr"/>
          <a:lstStyle/>
          <a:p>
            <a:pPr algn="ctr" defTabSz="1555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r>
              <a:rPr lang="en-US" altLang="ko-KR" sz="2000" i="1" dirty="0">
                <a:solidFill>
                  <a:srgbClr val="0000FF"/>
                </a:solidFill>
              </a:rPr>
              <a:t>M. </a:t>
            </a:r>
            <a:r>
              <a:rPr lang="en-US" altLang="ko-KR" sz="2000" i="1" dirty="0" err="1">
                <a:solidFill>
                  <a:srgbClr val="0000FF"/>
                </a:solidFill>
              </a:rPr>
              <a:t>catarrhalis</a:t>
            </a:r>
            <a:endParaRPr lang="en-US" altLang="ko-KR" sz="2000" i="1" dirty="0">
              <a:solidFill>
                <a:srgbClr val="0000FF"/>
              </a:solidFill>
            </a:endParaRPr>
          </a:p>
          <a:p>
            <a:pPr algn="ctr" defTabSz="1555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r>
              <a:rPr lang="en-US" altLang="ko-KR" sz="2000" b="1" dirty="0">
                <a:solidFill>
                  <a:schemeClr val="tx1"/>
                </a:solidFill>
              </a:rPr>
              <a:t>Type strain</a:t>
            </a:r>
          </a:p>
          <a:p>
            <a:pPr algn="ctr" defTabSz="1555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r>
              <a:rPr lang="en-US" altLang="ko-KR" sz="2000" dirty="0">
                <a:solidFill>
                  <a:schemeClr val="tx1"/>
                </a:solidFill>
              </a:rPr>
              <a:t>(ATCC 25238</a:t>
            </a:r>
            <a:r>
              <a:rPr lang="en-US" altLang="ko-KR" sz="2000" baseline="30000" dirty="0">
                <a:solidFill>
                  <a:schemeClr val="tx1"/>
                </a:solidFill>
              </a:rPr>
              <a:t>T</a:t>
            </a:r>
            <a:r>
              <a:rPr lang="en-US" altLang="ko-KR" sz="2000" dirty="0">
                <a:solidFill>
                  <a:schemeClr val="tx1"/>
                </a:solidFill>
              </a:rPr>
              <a:t>)</a:t>
            </a:r>
            <a:endParaRPr lang="ko-KR" altLang="en-US" sz="2000" baseline="30000" dirty="0">
              <a:solidFill>
                <a:schemeClr val="tx1"/>
              </a:solidFill>
            </a:endParaRPr>
          </a:p>
        </p:txBody>
      </p:sp>
      <p:sp>
        <p:nvSpPr>
          <p:cNvPr id="13" name="자유형 12"/>
          <p:cNvSpPr/>
          <p:nvPr/>
        </p:nvSpPr>
        <p:spPr>
          <a:xfrm>
            <a:off x="3113088" y="2818991"/>
            <a:ext cx="3024187" cy="420687"/>
          </a:xfrm>
          <a:custGeom>
            <a:avLst/>
            <a:gdLst>
              <a:gd name="connsiteX0" fmla="*/ 0 w 1096445"/>
              <a:gd name="connsiteY0" fmla="*/ 184138 h 368275"/>
              <a:gd name="connsiteX1" fmla="*/ 184138 w 1096445"/>
              <a:gd name="connsiteY1" fmla="*/ 0 h 368275"/>
              <a:gd name="connsiteX2" fmla="*/ 184138 w 1096445"/>
              <a:gd name="connsiteY2" fmla="*/ 73655 h 368275"/>
              <a:gd name="connsiteX3" fmla="*/ 912308 w 1096445"/>
              <a:gd name="connsiteY3" fmla="*/ 73655 h 368275"/>
              <a:gd name="connsiteX4" fmla="*/ 912308 w 1096445"/>
              <a:gd name="connsiteY4" fmla="*/ 0 h 368275"/>
              <a:gd name="connsiteX5" fmla="*/ 1096445 w 1096445"/>
              <a:gd name="connsiteY5" fmla="*/ 184138 h 368275"/>
              <a:gd name="connsiteX6" fmla="*/ 912308 w 1096445"/>
              <a:gd name="connsiteY6" fmla="*/ 368275 h 368275"/>
              <a:gd name="connsiteX7" fmla="*/ 912308 w 1096445"/>
              <a:gd name="connsiteY7" fmla="*/ 294620 h 368275"/>
              <a:gd name="connsiteX8" fmla="*/ 184138 w 1096445"/>
              <a:gd name="connsiteY8" fmla="*/ 294620 h 368275"/>
              <a:gd name="connsiteX9" fmla="*/ 184138 w 1096445"/>
              <a:gd name="connsiteY9" fmla="*/ 368275 h 368275"/>
              <a:gd name="connsiteX10" fmla="*/ 0 w 1096445"/>
              <a:gd name="connsiteY10" fmla="*/ 184138 h 368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096445" h="368275">
                <a:moveTo>
                  <a:pt x="1096445" y="184137"/>
                </a:moveTo>
                <a:lnTo>
                  <a:pt x="912307" y="368274"/>
                </a:lnTo>
                <a:lnTo>
                  <a:pt x="912307" y="294619"/>
                </a:lnTo>
                <a:lnTo>
                  <a:pt x="184137" y="294619"/>
                </a:lnTo>
                <a:lnTo>
                  <a:pt x="184137" y="368274"/>
                </a:lnTo>
                <a:lnTo>
                  <a:pt x="0" y="184137"/>
                </a:lnTo>
                <a:lnTo>
                  <a:pt x="184137" y="1"/>
                </a:lnTo>
                <a:lnTo>
                  <a:pt x="184137" y="73656"/>
                </a:lnTo>
                <a:lnTo>
                  <a:pt x="912307" y="73656"/>
                </a:lnTo>
                <a:lnTo>
                  <a:pt x="912307" y="1"/>
                </a:lnTo>
                <a:lnTo>
                  <a:pt x="1096445" y="184137"/>
                </a:lnTo>
                <a:close/>
              </a:path>
            </a:pathLst>
          </a:custGeom>
          <a:solidFill>
            <a:schemeClr val="accent5">
              <a:lumMod val="20000"/>
              <a:lumOff val="80000"/>
            </a:schemeClr>
          </a:solidFill>
        </p:spPr>
        <p:style>
          <a:lnRef idx="0">
            <a:schemeClr val="accent1">
              <a:tint val="6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tint val="6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tint val="60000"/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lIns="110482" tIns="73656" rIns="110484" bIns="73655" spcCol="1270" anchor="ctr"/>
          <a:lstStyle/>
          <a:p>
            <a:pPr algn="ctr" defTabSz="666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endParaRPr lang="ko-KR" altLang="en-US" sz="1500"/>
          </a:p>
        </p:txBody>
      </p:sp>
      <p:sp>
        <p:nvSpPr>
          <p:cNvPr id="14" name="자유형 13"/>
          <p:cNvSpPr/>
          <p:nvPr/>
        </p:nvSpPr>
        <p:spPr>
          <a:xfrm>
            <a:off x="222250" y="2428466"/>
            <a:ext cx="2454275" cy="1201737"/>
          </a:xfrm>
          <a:custGeom>
            <a:avLst/>
            <a:gdLst>
              <a:gd name="connsiteX0" fmla="*/ 0 w 2104429"/>
              <a:gd name="connsiteY0" fmla="*/ 105221 h 1052214"/>
              <a:gd name="connsiteX1" fmla="*/ 105221 w 2104429"/>
              <a:gd name="connsiteY1" fmla="*/ 0 h 1052214"/>
              <a:gd name="connsiteX2" fmla="*/ 1999208 w 2104429"/>
              <a:gd name="connsiteY2" fmla="*/ 0 h 1052214"/>
              <a:gd name="connsiteX3" fmla="*/ 2104429 w 2104429"/>
              <a:gd name="connsiteY3" fmla="*/ 105221 h 1052214"/>
              <a:gd name="connsiteX4" fmla="*/ 2104429 w 2104429"/>
              <a:gd name="connsiteY4" fmla="*/ 946993 h 1052214"/>
              <a:gd name="connsiteX5" fmla="*/ 1999208 w 2104429"/>
              <a:gd name="connsiteY5" fmla="*/ 1052214 h 1052214"/>
              <a:gd name="connsiteX6" fmla="*/ 105221 w 2104429"/>
              <a:gd name="connsiteY6" fmla="*/ 1052214 h 1052214"/>
              <a:gd name="connsiteX7" fmla="*/ 0 w 2104429"/>
              <a:gd name="connsiteY7" fmla="*/ 946993 h 1052214"/>
              <a:gd name="connsiteX8" fmla="*/ 0 w 2104429"/>
              <a:gd name="connsiteY8" fmla="*/ 105221 h 10522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104429" h="1052214">
                <a:moveTo>
                  <a:pt x="0" y="105221"/>
                </a:moveTo>
                <a:cubicBezTo>
                  <a:pt x="0" y="47109"/>
                  <a:pt x="47109" y="0"/>
                  <a:pt x="105221" y="0"/>
                </a:cubicBezTo>
                <a:lnTo>
                  <a:pt x="1999208" y="0"/>
                </a:lnTo>
                <a:cubicBezTo>
                  <a:pt x="2057320" y="0"/>
                  <a:pt x="2104429" y="47109"/>
                  <a:pt x="2104429" y="105221"/>
                </a:cubicBezTo>
                <a:lnTo>
                  <a:pt x="2104429" y="946993"/>
                </a:lnTo>
                <a:cubicBezTo>
                  <a:pt x="2104429" y="1005105"/>
                  <a:pt x="2057320" y="1052214"/>
                  <a:pt x="1999208" y="1052214"/>
                </a:cubicBezTo>
                <a:lnTo>
                  <a:pt x="105221" y="1052214"/>
                </a:lnTo>
                <a:cubicBezTo>
                  <a:pt x="47109" y="1052214"/>
                  <a:pt x="0" y="1005105"/>
                  <a:pt x="0" y="946993"/>
                </a:cubicBezTo>
                <a:lnTo>
                  <a:pt x="0" y="105221"/>
                </a:lnTo>
                <a:close/>
              </a:path>
            </a:pathLst>
          </a:cu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lIns="164168" tIns="164168" rIns="164168" bIns="164168" spcCol="1270" anchor="ctr"/>
          <a:lstStyle/>
          <a:p>
            <a:pPr algn="ctr" defTabSz="1555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r>
              <a:rPr lang="en-US" altLang="ko-KR" sz="2000" i="1" dirty="0">
                <a:solidFill>
                  <a:srgbClr val="FF0000"/>
                </a:solidFill>
              </a:rPr>
              <a:t>M. </a:t>
            </a:r>
            <a:r>
              <a:rPr lang="en-US" altLang="ko-KR" sz="2000" i="1" dirty="0" err="1">
                <a:solidFill>
                  <a:srgbClr val="FF0000"/>
                </a:solidFill>
              </a:rPr>
              <a:t>nonliquefaciens</a:t>
            </a:r>
            <a:endParaRPr lang="en-US" altLang="ko-KR" sz="2000" i="1" dirty="0">
              <a:solidFill>
                <a:srgbClr val="FF0000"/>
              </a:solidFill>
            </a:endParaRPr>
          </a:p>
          <a:p>
            <a:pPr algn="ctr" defTabSz="1555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r>
              <a:rPr lang="en-US" altLang="ko-KR" sz="2000" b="1" dirty="0">
                <a:solidFill>
                  <a:schemeClr val="tx1"/>
                </a:solidFill>
              </a:rPr>
              <a:t>Type strain</a:t>
            </a:r>
          </a:p>
          <a:p>
            <a:pPr algn="ctr" defTabSz="1555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r>
              <a:rPr lang="en-US" altLang="ko-KR" sz="2000" dirty="0">
                <a:solidFill>
                  <a:schemeClr val="tx1"/>
                </a:solidFill>
              </a:rPr>
              <a:t>(DSM 6327</a:t>
            </a:r>
            <a:r>
              <a:rPr lang="en-US" altLang="ko-KR" sz="2000" baseline="30000" dirty="0">
                <a:solidFill>
                  <a:schemeClr val="tx1"/>
                </a:solidFill>
              </a:rPr>
              <a:t>T</a:t>
            </a:r>
            <a:r>
              <a:rPr lang="en-US" altLang="ko-KR" sz="2000" dirty="0">
                <a:solidFill>
                  <a:schemeClr val="tx1"/>
                </a:solidFill>
              </a:rPr>
              <a:t>)</a:t>
            </a:r>
            <a:endParaRPr lang="ko-KR" altLang="en-US" sz="2000" baseline="30000" dirty="0">
              <a:solidFill>
                <a:schemeClr val="tx1"/>
              </a:solidFill>
            </a:endParaRPr>
          </a:p>
        </p:txBody>
      </p:sp>
      <p:sp>
        <p:nvSpPr>
          <p:cNvPr id="17" name="자유형 16"/>
          <p:cNvSpPr/>
          <p:nvPr/>
        </p:nvSpPr>
        <p:spPr>
          <a:xfrm>
            <a:off x="3927475" y="4711291"/>
            <a:ext cx="2595563" cy="1201737"/>
          </a:xfrm>
          <a:custGeom>
            <a:avLst/>
            <a:gdLst>
              <a:gd name="connsiteX0" fmla="*/ 0 w 2104429"/>
              <a:gd name="connsiteY0" fmla="*/ 105221 h 1052214"/>
              <a:gd name="connsiteX1" fmla="*/ 105221 w 2104429"/>
              <a:gd name="connsiteY1" fmla="*/ 0 h 1052214"/>
              <a:gd name="connsiteX2" fmla="*/ 1999208 w 2104429"/>
              <a:gd name="connsiteY2" fmla="*/ 0 h 1052214"/>
              <a:gd name="connsiteX3" fmla="*/ 2104429 w 2104429"/>
              <a:gd name="connsiteY3" fmla="*/ 105221 h 1052214"/>
              <a:gd name="connsiteX4" fmla="*/ 2104429 w 2104429"/>
              <a:gd name="connsiteY4" fmla="*/ 946993 h 1052214"/>
              <a:gd name="connsiteX5" fmla="*/ 1999208 w 2104429"/>
              <a:gd name="connsiteY5" fmla="*/ 1052214 h 1052214"/>
              <a:gd name="connsiteX6" fmla="*/ 105221 w 2104429"/>
              <a:gd name="connsiteY6" fmla="*/ 1052214 h 1052214"/>
              <a:gd name="connsiteX7" fmla="*/ 0 w 2104429"/>
              <a:gd name="connsiteY7" fmla="*/ 946993 h 1052214"/>
              <a:gd name="connsiteX8" fmla="*/ 0 w 2104429"/>
              <a:gd name="connsiteY8" fmla="*/ 105221 h 10522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104429" h="1052214">
                <a:moveTo>
                  <a:pt x="0" y="105221"/>
                </a:moveTo>
                <a:cubicBezTo>
                  <a:pt x="0" y="47109"/>
                  <a:pt x="47109" y="0"/>
                  <a:pt x="105221" y="0"/>
                </a:cubicBezTo>
                <a:lnTo>
                  <a:pt x="1999208" y="0"/>
                </a:lnTo>
                <a:cubicBezTo>
                  <a:pt x="2057320" y="0"/>
                  <a:pt x="2104429" y="47109"/>
                  <a:pt x="2104429" y="105221"/>
                </a:cubicBezTo>
                <a:lnTo>
                  <a:pt x="2104429" y="946993"/>
                </a:lnTo>
                <a:cubicBezTo>
                  <a:pt x="2104429" y="1005105"/>
                  <a:pt x="2057320" y="1052214"/>
                  <a:pt x="1999208" y="1052214"/>
                </a:cubicBezTo>
                <a:lnTo>
                  <a:pt x="105221" y="1052214"/>
                </a:lnTo>
                <a:cubicBezTo>
                  <a:pt x="47109" y="1052214"/>
                  <a:pt x="0" y="1005105"/>
                  <a:pt x="0" y="946993"/>
                </a:cubicBezTo>
                <a:lnTo>
                  <a:pt x="0" y="105221"/>
                </a:lnTo>
                <a:close/>
              </a:path>
            </a:pathLst>
          </a:cu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lIns="164168" tIns="164168" rIns="164168" bIns="164168" spcCol="1270" anchor="ctr"/>
          <a:lstStyle/>
          <a:p>
            <a:pPr algn="ctr" defTabSz="1555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r>
              <a:rPr lang="en-US" altLang="ko-KR" sz="2000" dirty="0" err="1">
                <a:solidFill>
                  <a:srgbClr val="0000FF"/>
                </a:solidFill>
              </a:rPr>
              <a:t>Clade</a:t>
            </a:r>
            <a:r>
              <a:rPr lang="en-US" altLang="ko-KR" sz="2000" dirty="0">
                <a:solidFill>
                  <a:srgbClr val="0000FF"/>
                </a:solidFill>
              </a:rPr>
              <a:t> II</a:t>
            </a:r>
          </a:p>
          <a:p>
            <a:pPr algn="ctr" defTabSz="1555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r>
              <a:rPr lang="en-US" altLang="ko-KR" sz="2000" b="1" dirty="0" err="1"/>
              <a:t>Contigs</a:t>
            </a:r>
            <a:r>
              <a:rPr lang="en-US" altLang="ko-KR" sz="2000" b="1" dirty="0"/>
              <a:t> from patients</a:t>
            </a:r>
          </a:p>
        </p:txBody>
      </p:sp>
      <p:sp>
        <p:nvSpPr>
          <p:cNvPr id="18" name="자유형 17"/>
          <p:cNvSpPr/>
          <p:nvPr/>
        </p:nvSpPr>
        <p:spPr>
          <a:xfrm rot="18900000" flipH="1">
            <a:off x="1258094" y="1610109"/>
            <a:ext cx="1252538" cy="428625"/>
          </a:xfrm>
          <a:custGeom>
            <a:avLst/>
            <a:gdLst>
              <a:gd name="connsiteX0" fmla="*/ 0 w 1096445"/>
              <a:gd name="connsiteY0" fmla="*/ 184138 h 368275"/>
              <a:gd name="connsiteX1" fmla="*/ 184138 w 1096445"/>
              <a:gd name="connsiteY1" fmla="*/ 0 h 368275"/>
              <a:gd name="connsiteX2" fmla="*/ 184138 w 1096445"/>
              <a:gd name="connsiteY2" fmla="*/ 73655 h 368275"/>
              <a:gd name="connsiteX3" fmla="*/ 912308 w 1096445"/>
              <a:gd name="connsiteY3" fmla="*/ 73655 h 368275"/>
              <a:gd name="connsiteX4" fmla="*/ 912308 w 1096445"/>
              <a:gd name="connsiteY4" fmla="*/ 0 h 368275"/>
              <a:gd name="connsiteX5" fmla="*/ 1096445 w 1096445"/>
              <a:gd name="connsiteY5" fmla="*/ 184138 h 368275"/>
              <a:gd name="connsiteX6" fmla="*/ 912308 w 1096445"/>
              <a:gd name="connsiteY6" fmla="*/ 368275 h 368275"/>
              <a:gd name="connsiteX7" fmla="*/ 912308 w 1096445"/>
              <a:gd name="connsiteY7" fmla="*/ 294620 h 368275"/>
              <a:gd name="connsiteX8" fmla="*/ 184138 w 1096445"/>
              <a:gd name="connsiteY8" fmla="*/ 294620 h 368275"/>
              <a:gd name="connsiteX9" fmla="*/ 184138 w 1096445"/>
              <a:gd name="connsiteY9" fmla="*/ 368275 h 368275"/>
              <a:gd name="connsiteX10" fmla="*/ 0 w 1096445"/>
              <a:gd name="connsiteY10" fmla="*/ 184138 h 368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096445" h="368275">
                <a:moveTo>
                  <a:pt x="0" y="184138"/>
                </a:moveTo>
                <a:lnTo>
                  <a:pt x="184138" y="0"/>
                </a:lnTo>
                <a:lnTo>
                  <a:pt x="184138" y="73655"/>
                </a:lnTo>
                <a:lnTo>
                  <a:pt x="912308" y="73655"/>
                </a:lnTo>
                <a:lnTo>
                  <a:pt x="912308" y="0"/>
                </a:lnTo>
                <a:lnTo>
                  <a:pt x="1096445" y="184138"/>
                </a:lnTo>
                <a:lnTo>
                  <a:pt x="912308" y="368275"/>
                </a:lnTo>
                <a:lnTo>
                  <a:pt x="912308" y="294620"/>
                </a:lnTo>
                <a:lnTo>
                  <a:pt x="184138" y="294620"/>
                </a:lnTo>
                <a:lnTo>
                  <a:pt x="184138" y="368275"/>
                </a:lnTo>
                <a:lnTo>
                  <a:pt x="0" y="184138"/>
                </a:lnTo>
                <a:close/>
              </a:path>
            </a:pathLst>
          </a:custGeom>
          <a:solidFill>
            <a:schemeClr val="accent5">
              <a:lumMod val="20000"/>
              <a:lumOff val="80000"/>
            </a:schemeClr>
          </a:solidFill>
        </p:spPr>
        <p:style>
          <a:lnRef idx="0">
            <a:schemeClr val="accent1">
              <a:tint val="6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tint val="6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tint val="60000"/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lIns="110482" tIns="73653" rIns="110482" bIns="73656" spcCol="1270" anchor="ctr"/>
          <a:lstStyle/>
          <a:p>
            <a:pPr algn="ctr" defTabSz="666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endParaRPr lang="ko-KR" altLang="en-US" sz="1500"/>
          </a:p>
        </p:txBody>
      </p:sp>
      <p:sp>
        <p:nvSpPr>
          <p:cNvPr id="19" name="자유형 18"/>
          <p:cNvSpPr/>
          <p:nvPr/>
        </p:nvSpPr>
        <p:spPr>
          <a:xfrm rot="2700000" flipH="1" flipV="1">
            <a:off x="1857375" y="4338228"/>
            <a:ext cx="2195513" cy="430213"/>
          </a:xfrm>
          <a:custGeom>
            <a:avLst/>
            <a:gdLst>
              <a:gd name="connsiteX0" fmla="*/ 0 w 1096445"/>
              <a:gd name="connsiteY0" fmla="*/ 184138 h 368275"/>
              <a:gd name="connsiteX1" fmla="*/ 184138 w 1096445"/>
              <a:gd name="connsiteY1" fmla="*/ 0 h 368275"/>
              <a:gd name="connsiteX2" fmla="*/ 184138 w 1096445"/>
              <a:gd name="connsiteY2" fmla="*/ 73655 h 368275"/>
              <a:gd name="connsiteX3" fmla="*/ 912308 w 1096445"/>
              <a:gd name="connsiteY3" fmla="*/ 73655 h 368275"/>
              <a:gd name="connsiteX4" fmla="*/ 912308 w 1096445"/>
              <a:gd name="connsiteY4" fmla="*/ 0 h 368275"/>
              <a:gd name="connsiteX5" fmla="*/ 1096445 w 1096445"/>
              <a:gd name="connsiteY5" fmla="*/ 184138 h 368275"/>
              <a:gd name="connsiteX6" fmla="*/ 912308 w 1096445"/>
              <a:gd name="connsiteY6" fmla="*/ 368275 h 368275"/>
              <a:gd name="connsiteX7" fmla="*/ 912308 w 1096445"/>
              <a:gd name="connsiteY7" fmla="*/ 294620 h 368275"/>
              <a:gd name="connsiteX8" fmla="*/ 184138 w 1096445"/>
              <a:gd name="connsiteY8" fmla="*/ 294620 h 368275"/>
              <a:gd name="connsiteX9" fmla="*/ 184138 w 1096445"/>
              <a:gd name="connsiteY9" fmla="*/ 368275 h 368275"/>
              <a:gd name="connsiteX10" fmla="*/ 0 w 1096445"/>
              <a:gd name="connsiteY10" fmla="*/ 184138 h 368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096445" h="368275">
                <a:moveTo>
                  <a:pt x="0" y="184138"/>
                </a:moveTo>
                <a:lnTo>
                  <a:pt x="184138" y="0"/>
                </a:lnTo>
                <a:lnTo>
                  <a:pt x="184138" y="73655"/>
                </a:lnTo>
                <a:lnTo>
                  <a:pt x="912308" y="73655"/>
                </a:lnTo>
                <a:lnTo>
                  <a:pt x="912308" y="0"/>
                </a:lnTo>
                <a:lnTo>
                  <a:pt x="1096445" y="184138"/>
                </a:lnTo>
                <a:lnTo>
                  <a:pt x="912308" y="368275"/>
                </a:lnTo>
                <a:lnTo>
                  <a:pt x="912308" y="294620"/>
                </a:lnTo>
                <a:lnTo>
                  <a:pt x="184138" y="294620"/>
                </a:lnTo>
                <a:lnTo>
                  <a:pt x="184138" y="368275"/>
                </a:lnTo>
                <a:lnTo>
                  <a:pt x="0" y="184138"/>
                </a:lnTo>
                <a:close/>
              </a:path>
            </a:pathLst>
          </a:custGeom>
          <a:solidFill>
            <a:schemeClr val="accent5">
              <a:lumMod val="20000"/>
              <a:lumOff val="80000"/>
            </a:schemeClr>
          </a:solidFill>
        </p:spPr>
        <p:style>
          <a:lnRef idx="0">
            <a:schemeClr val="accent1">
              <a:tint val="6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tint val="6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tint val="60000"/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lIns="110482" tIns="73653" rIns="110482" bIns="73656" spcCol="1270" anchor="ctr"/>
          <a:lstStyle/>
          <a:p>
            <a:pPr algn="ctr" defTabSz="666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endParaRPr lang="ko-KR" altLang="en-US" sz="1500"/>
          </a:p>
        </p:txBody>
      </p:sp>
      <p:sp>
        <p:nvSpPr>
          <p:cNvPr id="20" name="자유형 19"/>
          <p:cNvSpPr/>
          <p:nvPr/>
        </p:nvSpPr>
        <p:spPr>
          <a:xfrm rot="18900000" flipV="1">
            <a:off x="6535738" y="4015966"/>
            <a:ext cx="1254125" cy="428625"/>
          </a:xfrm>
          <a:custGeom>
            <a:avLst/>
            <a:gdLst>
              <a:gd name="connsiteX0" fmla="*/ 0 w 1096445"/>
              <a:gd name="connsiteY0" fmla="*/ 184138 h 368275"/>
              <a:gd name="connsiteX1" fmla="*/ 184138 w 1096445"/>
              <a:gd name="connsiteY1" fmla="*/ 0 h 368275"/>
              <a:gd name="connsiteX2" fmla="*/ 184138 w 1096445"/>
              <a:gd name="connsiteY2" fmla="*/ 73655 h 368275"/>
              <a:gd name="connsiteX3" fmla="*/ 912308 w 1096445"/>
              <a:gd name="connsiteY3" fmla="*/ 73655 h 368275"/>
              <a:gd name="connsiteX4" fmla="*/ 912308 w 1096445"/>
              <a:gd name="connsiteY4" fmla="*/ 0 h 368275"/>
              <a:gd name="connsiteX5" fmla="*/ 1096445 w 1096445"/>
              <a:gd name="connsiteY5" fmla="*/ 184138 h 368275"/>
              <a:gd name="connsiteX6" fmla="*/ 912308 w 1096445"/>
              <a:gd name="connsiteY6" fmla="*/ 368275 h 368275"/>
              <a:gd name="connsiteX7" fmla="*/ 912308 w 1096445"/>
              <a:gd name="connsiteY7" fmla="*/ 294620 h 368275"/>
              <a:gd name="connsiteX8" fmla="*/ 184138 w 1096445"/>
              <a:gd name="connsiteY8" fmla="*/ 294620 h 368275"/>
              <a:gd name="connsiteX9" fmla="*/ 184138 w 1096445"/>
              <a:gd name="connsiteY9" fmla="*/ 368275 h 368275"/>
              <a:gd name="connsiteX10" fmla="*/ 0 w 1096445"/>
              <a:gd name="connsiteY10" fmla="*/ 184138 h 368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096445" h="368275">
                <a:moveTo>
                  <a:pt x="0" y="184138"/>
                </a:moveTo>
                <a:lnTo>
                  <a:pt x="184138" y="0"/>
                </a:lnTo>
                <a:lnTo>
                  <a:pt x="184138" y="73655"/>
                </a:lnTo>
                <a:lnTo>
                  <a:pt x="912308" y="73655"/>
                </a:lnTo>
                <a:lnTo>
                  <a:pt x="912308" y="0"/>
                </a:lnTo>
                <a:lnTo>
                  <a:pt x="1096445" y="184138"/>
                </a:lnTo>
                <a:lnTo>
                  <a:pt x="912308" y="368275"/>
                </a:lnTo>
                <a:lnTo>
                  <a:pt x="912308" y="294620"/>
                </a:lnTo>
                <a:lnTo>
                  <a:pt x="184138" y="294620"/>
                </a:lnTo>
                <a:lnTo>
                  <a:pt x="184138" y="368275"/>
                </a:lnTo>
                <a:lnTo>
                  <a:pt x="0" y="184138"/>
                </a:lnTo>
                <a:close/>
              </a:path>
            </a:pathLst>
          </a:custGeom>
          <a:solidFill>
            <a:schemeClr val="accent5">
              <a:lumMod val="20000"/>
              <a:lumOff val="80000"/>
            </a:schemeClr>
          </a:solidFill>
        </p:spPr>
        <p:style>
          <a:lnRef idx="0">
            <a:schemeClr val="accent1">
              <a:tint val="60000"/>
              <a:hueOff val="0"/>
              <a:satOff val="0"/>
              <a:lumOff val="0"/>
              <a:alphaOff val="0"/>
            </a:schemeClr>
          </a:lnRef>
          <a:fillRef idx="1">
            <a:schemeClr val="accent1">
              <a:tint val="6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tint val="60000"/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lIns="110482" tIns="73653" rIns="110482" bIns="73656" spcCol="1270" anchor="ctr"/>
          <a:lstStyle/>
          <a:p>
            <a:pPr algn="ctr" defTabSz="666750" eaLnBrk="1" fontAlgn="auto" latinLnBrk="1" hangingPunct="1">
              <a:lnSpc>
                <a:spcPct val="90000"/>
              </a:lnSpc>
              <a:spcAft>
                <a:spcPct val="35000"/>
              </a:spcAft>
              <a:defRPr/>
            </a:pPr>
            <a:endParaRPr lang="ko-KR" altLang="en-US" sz="1500"/>
          </a:p>
        </p:txBody>
      </p:sp>
      <p:sp>
        <p:nvSpPr>
          <p:cNvPr id="6156" name="TextBox 20"/>
          <p:cNvSpPr txBox="1">
            <a:spLocks noChangeArrowheads="1"/>
          </p:cNvSpPr>
          <p:nvPr/>
        </p:nvSpPr>
        <p:spPr bwMode="auto">
          <a:xfrm>
            <a:off x="3663950" y="2482441"/>
            <a:ext cx="199231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800" b="1"/>
              <a:t>16S rRNA = 98.4%</a:t>
            </a:r>
            <a:endParaRPr lang="ko-KR" altLang="en-US" sz="1800" b="1"/>
          </a:p>
        </p:txBody>
      </p:sp>
      <p:sp>
        <p:nvSpPr>
          <p:cNvPr id="6157" name="TextBox 21"/>
          <p:cNvSpPr txBox="1">
            <a:spLocks noChangeArrowheads="1"/>
          </p:cNvSpPr>
          <p:nvPr/>
        </p:nvSpPr>
        <p:spPr bwMode="auto">
          <a:xfrm>
            <a:off x="3590925" y="3204753"/>
            <a:ext cx="21923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800" b="1"/>
              <a:t>Genome ANI = 75%</a:t>
            </a:r>
            <a:endParaRPr lang="ko-KR" altLang="en-US" sz="1800" b="1"/>
          </a:p>
        </p:txBody>
      </p:sp>
      <p:sp>
        <p:nvSpPr>
          <p:cNvPr id="6158" name="TextBox 22"/>
          <p:cNvSpPr txBox="1">
            <a:spLocks noChangeArrowheads="1"/>
          </p:cNvSpPr>
          <p:nvPr/>
        </p:nvSpPr>
        <p:spPr bwMode="auto">
          <a:xfrm>
            <a:off x="7189788" y="4185828"/>
            <a:ext cx="1992312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800" b="1"/>
              <a:t>16S = 99.6-100%</a:t>
            </a:r>
            <a:endParaRPr lang="ko-KR" altLang="en-US" sz="1800" b="1"/>
          </a:p>
        </p:txBody>
      </p:sp>
      <p:sp>
        <p:nvSpPr>
          <p:cNvPr id="6159" name="TextBox 23"/>
          <p:cNvSpPr txBox="1">
            <a:spLocks noChangeArrowheads="1"/>
          </p:cNvSpPr>
          <p:nvPr/>
        </p:nvSpPr>
        <p:spPr bwMode="auto">
          <a:xfrm>
            <a:off x="6088063" y="1167991"/>
            <a:ext cx="199231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800" b="1"/>
              <a:t>16S = 93.7-95.4%</a:t>
            </a:r>
            <a:endParaRPr lang="ko-KR" altLang="en-US" sz="1800" b="1"/>
          </a:p>
        </p:txBody>
      </p:sp>
      <p:sp>
        <p:nvSpPr>
          <p:cNvPr id="6160" name="TextBox 24"/>
          <p:cNvSpPr txBox="1">
            <a:spLocks noChangeArrowheads="1"/>
          </p:cNvSpPr>
          <p:nvPr/>
        </p:nvSpPr>
        <p:spPr bwMode="auto">
          <a:xfrm>
            <a:off x="115888" y="1456916"/>
            <a:ext cx="199231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800" b="1"/>
              <a:t>16S = 98.5-99.8%</a:t>
            </a:r>
            <a:endParaRPr lang="ko-KR" altLang="en-US" sz="1800" b="1"/>
          </a:p>
        </p:txBody>
      </p:sp>
      <p:sp>
        <p:nvSpPr>
          <p:cNvPr id="6161" name="TextBox 25"/>
          <p:cNvSpPr txBox="1">
            <a:spLocks noChangeArrowheads="1"/>
          </p:cNvSpPr>
          <p:nvPr/>
        </p:nvSpPr>
        <p:spPr bwMode="auto">
          <a:xfrm>
            <a:off x="1184275" y="4490628"/>
            <a:ext cx="199231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800" b="1"/>
              <a:t>16S = 95.2-95.4%</a:t>
            </a:r>
            <a:endParaRPr lang="ko-KR" altLang="en-US" sz="1800" b="1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25</TotalTime>
  <Words>115</Words>
  <Application>Microsoft Office PowerPoint</Application>
  <PresentationFormat>화면 슬라이드 쇼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굴림</vt:lpstr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98</cp:revision>
  <cp:lastPrinted>2013-12-19T02:04:48Z</cp:lastPrinted>
  <dcterms:created xsi:type="dcterms:W3CDTF">2013-08-10T08:51:27Z</dcterms:created>
  <dcterms:modified xsi:type="dcterms:W3CDTF">2014-07-08T04:15:10Z</dcterms:modified>
</cp:coreProperties>
</file>